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3054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7439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5598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0352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892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987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2517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558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504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023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84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3730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BD449-57A9-4E23-BD3A-EE561C91A5CB}" type="datetimeFigureOut">
              <a:rPr kumimoji="1" lang="ja-JP" altLang="en-US" smtClean="0"/>
              <a:t>2026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FFD4B-A0DE-47F7-892D-853BA43EA5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281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044166E-A986-442B-A2EB-BE934F29F210}"/>
              </a:ext>
            </a:extLst>
          </p:cNvPr>
          <p:cNvSpPr/>
          <p:nvPr/>
        </p:nvSpPr>
        <p:spPr>
          <a:xfrm>
            <a:off x="4672038" y="464649"/>
            <a:ext cx="157831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/>
              <a:t>Hirayama I, et al.</a:t>
            </a:r>
            <a:endParaRPr lang="ja-JP" altLang="en-US" sz="1600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7DC6A49F-3862-40B3-A49E-C3CA9C1A2483}"/>
              </a:ext>
            </a:extLst>
          </p:cNvPr>
          <p:cNvSpPr/>
          <p:nvPr/>
        </p:nvSpPr>
        <p:spPr>
          <a:xfrm>
            <a:off x="768386" y="8518021"/>
            <a:ext cx="532122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/>
              <a:t>Supplementary Fig</a:t>
            </a:r>
            <a:r>
              <a:rPr lang="en-US" altLang="zh-CN"/>
              <a:t>ure</a:t>
            </a:r>
            <a:r>
              <a:rPr lang="en-US" altLang="ja-JP"/>
              <a:t> S</a:t>
            </a:r>
            <a:r>
              <a:rPr lang="en-US" altLang="ja-JP" dirty="0"/>
              <a:t>1</a:t>
            </a:r>
            <a:r>
              <a:rPr lang="en-US" altLang="ja-JP"/>
              <a:t>. </a:t>
            </a:r>
            <a:endParaRPr lang="en-US" altLang="ja-JP" dirty="0"/>
          </a:p>
          <a:p>
            <a:r>
              <a:rPr lang="en-US" altLang="ja-JP" dirty="0"/>
              <a:t>Scatter plot comparing serum albumin and prealbumin levels between 28-day survivors and non-survivors. 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FC22A6A-4603-27F6-6844-BF7BAED034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05903"/>
            <a:ext cx="6858000" cy="3094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0489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</TotalTime>
  <Words>24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Doi Kent</dc:creator>
  <cp:lastModifiedBy>MDPI</cp:lastModifiedBy>
  <cp:revision>29</cp:revision>
  <dcterms:created xsi:type="dcterms:W3CDTF">2020-06-04T05:18:21Z</dcterms:created>
  <dcterms:modified xsi:type="dcterms:W3CDTF">2026-02-25T04:28:10Z</dcterms:modified>
</cp:coreProperties>
</file>